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2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9" Type="http://schemas.openxmlformats.org/officeDocument/2006/relationships/image" Target="../media/image38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38" Type="http://schemas.openxmlformats.org/officeDocument/2006/relationships/image" Target="../media/image37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29" Type="http://schemas.openxmlformats.org/officeDocument/2006/relationships/image" Target="../media/image28.jpg"/><Relationship Id="rId41" Type="http://schemas.openxmlformats.org/officeDocument/2006/relationships/image" Target="../media/image4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45" Type="http://schemas.openxmlformats.org/officeDocument/2006/relationships/image" Target="../media/image44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36" Type="http://schemas.openxmlformats.org/officeDocument/2006/relationships/image" Target="../media/image35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4" Type="http://schemas.openxmlformats.org/officeDocument/2006/relationships/image" Target="../media/image43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Relationship Id="rId35" Type="http://schemas.openxmlformats.org/officeDocument/2006/relationships/image" Target="../media/image34.jpg"/><Relationship Id="rId43" Type="http://schemas.openxmlformats.org/officeDocument/2006/relationships/image" Target="../media/image4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7919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11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258098" y="1681532"/>
            <a:ext cx="1638033" cy="3276425"/>
            <a:chOff x="-53198" y="419930"/>
            <a:chExt cx="1638033" cy="3276425"/>
          </a:xfrm>
        </p:grpSpPr>
        <p:sp>
          <p:nvSpPr>
            <p:cNvPr id="11" name="テキスト ボックス 10"/>
            <p:cNvSpPr txBox="1"/>
            <p:nvPr/>
          </p:nvSpPr>
          <p:spPr>
            <a:xfrm>
              <a:off x="-53198" y="1111032"/>
              <a:ext cx="693908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ME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3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3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665994" y="419930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197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30217" y="1024776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00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721454" y="644619"/>
              <a:ext cx="527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094571" y="644619"/>
              <a:ext cx="4764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</a:t>
              </a: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69" name="図 6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48582" r="77889" b="48509"/>
          <a:stretch/>
        </p:blipFill>
        <p:spPr>
          <a:xfrm>
            <a:off x="900114" y="3604247"/>
            <a:ext cx="893741" cy="1385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図 8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" t="53225" r="77639" b="44145"/>
          <a:stretch/>
        </p:blipFill>
        <p:spPr>
          <a:xfrm>
            <a:off x="928299" y="4149746"/>
            <a:ext cx="891766" cy="1252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図 8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7" t="41600" r="77672" b="54618"/>
          <a:stretch/>
        </p:blipFill>
        <p:spPr>
          <a:xfrm>
            <a:off x="894918" y="2505245"/>
            <a:ext cx="890200" cy="1801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図 9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7" t="47418" r="77759" b="49382"/>
          <a:stretch/>
        </p:blipFill>
        <p:spPr>
          <a:xfrm>
            <a:off x="916566" y="3039151"/>
            <a:ext cx="886025" cy="152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図 9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" t="62400" r="77642" b="34600"/>
          <a:stretch/>
        </p:blipFill>
        <p:spPr>
          <a:xfrm>
            <a:off x="907670" y="4700127"/>
            <a:ext cx="912393" cy="1428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図 9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57600" r="77642" b="40000"/>
          <a:stretch/>
        </p:blipFill>
        <p:spPr>
          <a:xfrm>
            <a:off x="920896" y="3888915"/>
            <a:ext cx="893343" cy="114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図 9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60885" r="77764" b="35600"/>
          <a:stretch/>
        </p:blipFill>
        <p:spPr>
          <a:xfrm>
            <a:off x="920107" y="4408922"/>
            <a:ext cx="897044" cy="1673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図 9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0000" r="77731" b="57200"/>
          <a:stretch/>
        </p:blipFill>
        <p:spPr>
          <a:xfrm>
            <a:off x="911371" y="2776077"/>
            <a:ext cx="879572" cy="1333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図 95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57600" r="77520" b="39600"/>
          <a:stretch/>
        </p:blipFill>
        <p:spPr>
          <a:xfrm>
            <a:off x="930421" y="3309477"/>
            <a:ext cx="889643" cy="13335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7" name="グループ化 96"/>
          <p:cNvGrpSpPr/>
          <p:nvPr/>
        </p:nvGrpSpPr>
        <p:grpSpPr>
          <a:xfrm>
            <a:off x="2410590" y="1681532"/>
            <a:ext cx="1835684" cy="3276425"/>
            <a:chOff x="-53198" y="419930"/>
            <a:chExt cx="1835684" cy="3276425"/>
          </a:xfrm>
        </p:grpSpPr>
        <p:sp>
          <p:nvSpPr>
            <p:cNvPr id="98" name="テキスト ボックス 97"/>
            <p:cNvSpPr txBox="1"/>
            <p:nvPr/>
          </p:nvSpPr>
          <p:spPr>
            <a:xfrm>
              <a:off x="-53198" y="1111032"/>
              <a:ext cx="693908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ME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3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3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712751" y="419930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358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630217" y="1024776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00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721454" y="644619"/>
              <a:ext cx="527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>
              <a:off x="1094571" y="644619"/>
              <a:ext cx="4764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</a:t>
              </a: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テキスト ボックス 102"/>
            <p:cNvSpPr txBox="1"/>
            <p:nvPr/>
          </p:nvSpPr>
          <p:spPr>
            <a:xfrm>
              <a:off x="1597755" y="644619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8" name="グループ化 117"/>
          <p:cNvGrpSpPr/>
          <p:nvPr/>
        </p:nvGrpSpPr>
        <p:grpSpPr>
          <a:xfrm>
            <a:off x="4839781" y="1681532"/>
            <a:ext cx="1669205" cy="3276425"/>
            <a:chOff x="-53198" y="419930"/>
            <a:chExt cx="1669205" cy="3276425"/>
          </a:xfrm>
        </p:grpSpPr>
        <p:sp>
          <p:nvSpPr>
            <p:cNvPr id="119" name="テキスト ボックス 118"/>
            <p:cNvSpPr txBox="1"/>
            <p:nvPr/>
          </p:nvSpPr>
          <p:spPr>
            <a:xfrm>
              <a:off x="-53198" y="1111032"/>
              <a:ext cx="693908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ME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3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3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テキスト ボックス 119"/>
            <p:cNvSpPr txBox="1"/>
            <p:nvPr/>
          </p:nvSpPr>
          <p:spPr>
            <a:xfrm>
              <a:off x="697166" y="419930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1781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630217" y="1024776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00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テキスト ボックス 121"/>
            <p:cNvSpPr txBox="1"/>
            <p:nvPr/>
          </p:nvSpPr>
          <p:spPr>
            <a:xfrm>
              <a:off x="721454" y="644619"/>
              <a:ext cx="527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テキスト ボックス 122"/>
            <p:cNvSpPr txBox="1"/>
            <p:nvPr/>
          </p:nvSpPr>
          <p:spPr>
            <a:xfrm>
              <a:off x="1094571" y="644619"/>
              <a:ext cx="4764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</a:t>
              </a: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グループ化 124"/>
          <p:cNvGrpSpPr/>
          <p:nvPr/>
        </p:nvGrpSpPr>
        <p:grpSpPr>
          <a:xfrm>
            <a:off x="7428104" y="1681532"/>
            <a:ext cx="1624181" cy="3276425"/>
            <a:chOff x="-53198" y="419930"/>
            <a:chExt cx="1624181" cy="3276425"/>
          </a:xfrm>
        </p:grpSpPr>
        <p:sp>
          <p:nvSpPr>
            <p:cNvPr id="127" name="テキスト ボックス 126"/>
            <p:cNvSpPr txBox="1"/>
            <p:nvPr/>
          </p:nvSpPr>
          <p:spPr>
            <a:xfrm>
              <a:off x="640017" y="419930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175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テキスト ボックス 127"/>
            <p:cNvSpPr txBox="1"/>
            <p:nvPr/>
          </p:nvSpPr>
          <p:spPr>
            <a:xfrm>
              <a:off x="630217" y="1024776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00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テキスト ボックス 128"/>
            <p:cNvSpPr txBox="1"/>
            <p:nvPr/>
          </p:nvSpPr>
          <p:spPr>
            <a:xfrm>
              <a:off x="721454" y="644619"/>
              <a:ext cx="527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テキスト ボックス 129"/>
            <p:cNvSpPr txBox="1"/>
            <p:nvPr/>
          </p:nvSpPr>
          <p:spPr>
            <a:xfrm>
              <a:off x="1094571" y="644619"/>
              <a:ext cx="4764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</a:t>
              </a: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テキスト ボックス 125"/>
            <p:cNvSpPr txBox="1"/>
            <p:nvPr/>
          </p:nvSpPr>
          <p:spPr>
            <a:xfrm>
              <a:off x="-53198" y="1111032"/>
              <a:ext cx="693908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ME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3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3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32" name="図 131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8" t="48724" r="77473" b="48549"/>
          <a:stretch/>
        </p:blipFill>
        <p:spPr>
          <a:xfrm>
            <a:off x="3088564" y="3587709"/>
            <a:ext cx="901015" cy="1299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3" name="図 132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53162" r="77590" b="44145"/>
          <a:stretch/>
        </p:blipFill>
        <p:spPr>
          <a:xfrm>
            <a:off x="3084550" y="4155568"/>
            <a:ext cx="907942" cy="1282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4" name="図 133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8" t="44509" r="77514" b="52353"/>
          <a:stretch/>
        </p:blipFill>
        <p:spPr>
          <a:xfrm>
            <a:off x="3086827" y="2521029"/>
            <a:ext cx="908577" cy="1494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5" name="図 134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4" t="47127" r="77628" b="49382"/>
          <a:stretch/>
        </p:blipFill>
        <p:spPr>
          <a:xfrm>
            <a:off x="3086828" y="3029416"/>
            <a:ext cx="882367" cy="1662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6" name="図 135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" t="62478" r="77809" b="35200"/>
          <a:stretch/>
        </p:blipFill>
        <p:spPr>
          <a:xfrm>
            <a:off x="3105764" y="4694308"/>
            <a:ext cx="866343" cy="1105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7" name="図 136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7" t="57199" r="77597" b="40172"/>
          <a:stretch/>
        </p:blipFill>
        <p:spPr>
          <a:xfrm>
            <a:off x="3110125" y="3873093"/>
            <a:ext cx="876544" cy="1252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8" name="図 137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4" t="60963" r="77781" b="36200"/>
          <a:stretch/>
        </p:blipFill>
        <p:spPr>
          <a:xfrm>
            <a:off x="3113036" y="4420570"/>
            <a:ext cx="876543" cy="1351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9" name="図 138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39800" r="77681" b="56600"/>
          <a:stretch/>
        </p:blipFill>
        <p:spPr>
          <a:xfrm>
            <a:off x="3086441" y="2762306"/>
            <a:ext cx="891490" cy="171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0" name="図 139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7" t="57589" r="77698" b="39598"/>
          <a:stretch/>
        </p:blipFill>
        <p:spPr>
          <a:xfrm>
            <a:off x="3098476" y="3313971"/>
            <a:ext cx="876543" cy="1339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2" name="図 161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8" t="49197" r="77583" b="47868"/>
          <a:stretch/>
        </p:blipFill>
        <p:spPr>
          <a:xfrm>
            <a:off x="5518433" y="3611005"/>
            <a:ext cx="888191" cy="1397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3" name="図 162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7" t="53253" r="77720" b="43854"/>
          <a:stretch/>
        </p:blipFill>
        <p:spPr>
          <a:xfrm>
            <a:off x="5512159" y="4141009"/>
            <a:ext cx="874080" cy="1377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4" name="図 163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7" t="46546" r="77367" b="50585"/>
          <a:stretch/>
        </p:blipFill>
        <p:spPr>
          <a:xfrm>
            <a:off x="5498305" y="2510442"/>
            <a:ext cx="890847" cy="136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5" name="図 164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4" t="47980" r="77705" b="49024"/>
          <a:stretch/>
        </p:blipFill>
        <p:spPr>
          <a:xfrm>
            <a:off x="5509697" y="3037322"/>
            <a:ext cx="891103" cy="142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6" name="図 165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" t="62972" r="77650" b="34600"/>
          <a:stretch/>
        </p:blipFill>
        <p:spPr>
          <a:xfrm>
            <a:off x="5500471" y="4679747"/>
            <a:ext cx="911978" cy="115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7" name="図 166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1" t="57746" r="77651" b="39320"/>
          <a:stretch/>
        </p:blipFill>
        <p:spPr>
          <a:xfrm>
            <a:off x="5527169" y="3867270"/>
            <a:ext cx="885279" cy="1397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8" name="図 167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61346" r="77695" b="36000"/>
          <a:stretch/>
        </p:blipFill>
        <p:spPr>
          <a:xfrm>
            <a:off x="5500471" y="4411835"/>
            <a:ext cx="900330" cy="1263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9" name="図 168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40800" r="77490" b="55655"/>
          <a:stretch/>
        </p:blipFill>
        <p:spPr>
          <a:xfrm>
            <a:off x="5514757" y="2766552"/>
            <a:ext cx="900604" cy="1688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0" name="図 169"/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" t="58200" r="77624" b="39182"/>
          <a:stretch/>
        </p:blipFill>
        <p:spPr>
          <a:xfrm>
            <a:off x="5516880" y="3326159"/>
            <a:ext cx="875183" cy="12468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71" name="グループ化 170"/>
          <p:cNvGrpSpPr/>
          <p:nvPr/>
        </p:nvGrpSpPr>
        <p:grpSpPr>
          <a:xfrm>
            <a:off x="9843034" y="1691057"/>
            <a:ext cx="1648424" cy="3276425"/>
            <a:chOff x="-53198" y="419930"/>
            <a:chExt cx="1648424" cy="3276425"/>
          </a:xfrm>
        </p:grpSpPr>
        <p:sp>
          <p:nvSpPr>
            <p:cNvPr id="172" name="テキスト ボックス 171"/>
            <p:cNvSpPr txBox="1"/>
            <p:nvPr/>
          </p:nvSpPr>
          <p:spPr>
            <a:xfrm>
              <a:off x="-53198" y="1111032"/>
              <a:ext cx="693908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ME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3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AT3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</a:p>
            <a:p>
              <a:pPr algn="r">
                <a:lnSpc>
                  <a:spcPct val="150000"/>
                </a:lnSpc>
              </a:pPr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676385" y="419930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1703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630217" y="1024776"/>
              <a:ext cx="915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00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721454" y="644619"/>
              <a:ext cx="527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</a:t>
              </a:r>
              <a:endPara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1094571" y="644619"/>
              <a:ext cx="4764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</a:t>
              </a:r>
            </a:p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78" name="図 177"/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1" t="57942" r="77656" b="38972"/>
          <a:stretch/>
        </p:blipFill>
        <p:spPr>
          <a:xfrm>
            <a:off x="8096421" y="3861371"/>
            <a:ext cx="884501" cy="1469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9" name="図 178"/>
          <p:cNvPicPr>
            <a:picLocks noChangeAspect="1"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" t="61372" r="77644" b="35200"/>
          <a:stretch/>
        </p:blipFill>
        <p:spPr>
          <a:xfrm>
            <a:off x="8088258" y="4404850"/>
            <a:ext cx="901402" cy="1632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0" name="図 179"/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" t="40114" r="77840" b="56114"/>
          <a:stretch/>
        </p:blipFill>
        <p:spPr>
          <a:xfrm>
            <a:off x="8080093" y="2777435"/>
            <a:ext cx="892093" cy="1796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1" name="図 180"/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1" t="49371" r="77851" b="47543"/>
          <a:stretch/>
        </p:blipFill>
        <p:spPr>
          <a:xfrm>
            <a:off x="8088257" y="3600424"/>
            <a:ext cx="875193" cy="1469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2" name="図 181"/>
          <p:cNvPicPr>
            <a:picLocks noChangeAspect="1"/>
          </p:cNvPicPr>
          <p:nvPr/>
        </p:nvPicPr>
        <p:blipFill rotWithShape="1"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" t="54171" r="77644" b="43226"/>
          <a:stretch/>
        </p:blipFill>
        <p:spPr>
          <a:xfrm>
            <a:off x="8088258" y="4136427"/>
            <a:ext cx="901402" cy="1239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3" name="図 182"/>
          <p:cNvPicPr>
            <a:picLocks noChangeAspect="1"/>
          </p:cNvPicPr>
          <p:nvPr/>
        </p:nvPicPr>
        <p:blipFill rotWithShape="1"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3" t="43424" r="77653" b="53371"/>
          <a:stretch/>
        </p:blipFill>
        <p:spPr>
          <a:xfrm>
            <a:off x="8057788" y="2510110"/>
            <a:ext cx="899839" cy="1526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4" name="図 183"/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1" t="46971" r="77730" b="49257"/>
          <a:stretch/>
        </p:blipFill>
        <p:spPr>
          <a:xfrm>
            <a:off x="8088257" y="3060464"/>
            <a:ext cx="881017" cy="1796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5" name="図 184"/>
          <p:cNvPicPr>
            <a:picLocks noChangeAspect="1"/>
          </p:cNvPicPr>
          <p:nvPr/>
        </p:nvPicPr>
        <p:blipFill rotWithShape="1"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" t="58629" r="77767" b="38285"/>
          <a:stretch/>
        </p:blipFill>
        <p:spPr>
          <a:xfrm>
            <a:off x="8088257" y="3313557"/>
            <a:ext cx="895577" cy="1469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6" name="図 185"/>
          <p:cNvPicPr>
            <a:picLocks noChangeAspect="1"/>
          </p:cNvPicPr>
          <p:nvPr/>
        </p:nvPicPr>
        <p:blipFill rotWithShape="1"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9" t="64001" r="77644" b="33708"/>
          <a:stretch/>
        </p:blipFill>
        <p:spPr>
          <a:xfrm>
            <a:off x="8088258" y="4698762"/>
            <a:ext cx="901402" cy="1091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7" name="図 186"/>
          <p:cNvPicPr>
            <a:picLocks noChangeAspect="1"/>
          </p:cNvPicPr>
          <p:nvPr/>
        </p:nvPicPr>
        <p:blipFill rotWithShape="1"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48297" r="77627" b="48218"/>
          <a:stretch/>
        </p:blipFill>
        <p:spPr>
          <a:xfrm>
            <a:off x="10543874" y="3581400"/>
            <a:ext cx="906180" cy="1659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8" name="図 187"/>
          <p:cNvPicPr>
            <a:picLocks noChangeAspect="1"/>
          </p:cNvPicPr>
          <p:nvPr/>
        </p:nvPicPr>
        <p:blipFill rotWithShape="1"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7" t="52930" r="77589" b="44145"/>
          <a:stretch/>
        </p:blipFill>
        <p:spPr>
          <a:xfrm>
            <a:off x="10557727" y="4146884"/>
            <a:ext cx="880294" cy="1393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9" name="図 188"/>
          <p:cNvPicPr>
            <a:picLocks noChangeAspect="1"/>
          </p:cNvPicPr>
          <p:nvPr/>
        </p:nvPicPr>
        <p:blipFill rotWithShape="1"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1" t="45019" r="77472" b="51779"/>
          <a:stretch/>
        </p:blipFill>
        <p:spPr>
          <a:xfrm>
            <a:off x="10547682" y="2526630"/>
            <a:ext cx="902370" cy="1524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0" name="図 189"/>
          <p:cNvPicPr>
            <a:picLocks noChangeAspect="1"/>
          </p:cNvPicPr>
          <p:nvPr/>
        </p:nvPicPr>
        <p:blipFill rotWithShape="1"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" t="47291" r="77796" b="49382"/>
          <a:stretch/>
        </p:blipFill>
        <p:spPr>
          <a:xfrm>
            <a:off x="10543873" y="3027947"/>
            <a:ext cx="898159" cy="158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1" name="図 190"/>
          <p:cNvPicPr>
            <a:picLocks noChangeAspect="1"/>
          </p:cNvPicPr>
          <p:nvPr/>
        </p:nvPicPr>
        <p:blipFill rotWithShape="1">
          <a:blip r:embed="rId4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62352" r="77634" b="34800"/>
          <a:stretch/>
        </p:blipFill>
        <p:spPr>
          <a:xfrm>
            <a:off x="10560325" y="4688305"/>
            <a:ext cx="893738" cy="135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2" name="図 191"/>
          <p:cNvPicPr>
            <a:picLocks noChangeAspect="1"/>
          </p:cNvPicPr>
          <p:nvPr/>
        </p:nvPicPr>
        <p:blipFill rotWithShape="1">
          <a:blip r:embed="rId4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56722" r="77603" b="40200"/>
          <a:stretch/>
        </p:blipFill>
        <p:spPr>
          <a:xfrm>
            <a:off x="10550800" y="3866147"/>
            <a:ext cx="895242" cy="1465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3" name="図 192"/>
          <p:cNvPicPr>
            <a:picLocks noChangeAspect="1"/>
          </p:cNvPicPr>
          <p:nvPr/>
        </p:nvPicPr>
        <p:blipFill rotWithShape="1">
          <a:blip r:embed="rId4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60426" r="77634" b="35800"/>
          <a:stretch/>
        </p:blipFill>
        <p:spPr>
          <a:xfrm>
            <a:off x="10550800" y="4415589"/>
            <a:ext cx="903263" cy="1797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4" name="図 193"/>
          <p:cNvPicPr>
            <a:picLocks noChangeAspect="1"/>
          </p:cNvPicPr>
          <p:nvPr/>
        </p:nvPicPr>
        <p:blipFill rotWithShape="1">
          <a:blip r:embed="rId4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40215" r="77402" b="56600"/>
          <a:stretch/>
        </p:blipFill>
        <p:spPr>
          <a:xfrm>
            <a:off x="10541275" y="2767262"/>
            <a:ext cx="904767" cy="1516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5" name="図 194"/>
          <p:cNvPicPr>
            <a:picLocks noChangeAspect="1"/>
          </p:cNvPicPr>
          <p:nvPr/>
        </p:nvPicPr>
        <p:blipFill rotWithShape="1"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58204" r="77549" b="39800"/>
          <a:stretch/>
        </p:blipFill>
        <p:spPr>
          <a:xfrm>
            <a:off x="10550800" y="3328737"/>
            <a:ext cx="907274" cy="12210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2144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88</Words>
  <Application>Microsoft Office PowerPoint</Application>
  <PresentationFormat>ワイド画面</PresentationFormat>
  <Paragraphs>7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56:05Z</dcterms:modified>
</cp:coreProperties>
</file>